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5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79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62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7EBD81-DDCF-4394-9D53-15499AAC64DC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4EFCC3-C08D-42E9-AE17-D801792739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336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CD5166-24B3-4E19-B995-E052CAF2FD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A9420C-74C9-49BB-AD41-28EE86C587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BC8B18-351C-48E0-9472-A63092294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E053A5-2EE6-4B5B-8C68-7AEFBAB58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5936FA-2ECA-4E12-972C-072926AAC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836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2DB603-F780-4278-B99F-10B213E58F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824337-225E-4619-AD80-82B24D9805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CBD175-7A87-4606-B941-02F2CC391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C3B324-66A8-4E27-AB83-83D80A714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3F7DD6-8B32-49D5-8C6C-67425064C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331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758E29-E635-4399-9CD9-46327BC7CB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6CAEA6-0304-4E7E-8DD9-4E7B3FDE73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822AF5-7E5B-41E4-BB84-26BB63BB6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7E407D-22C3-4181-9B8D-6F5788264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F47847-837C-4827-8211-DE386ABD20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4094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984A5-DD37-4F65-A5C6-00D491475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A43F39-45A7-4064-9419-38FA43480A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BCFF4C-3DBE-4D7D-9D82-2B7311D9B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296C82-54D2-4335-B75E-98F7FD02A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0A9AE4-4915-4B70-ADF9-8803E011B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64574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FF222-E43C-497F-A8A0-86E98E72D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078A5E-6C7F-4F2A-BC05-AF16FFE720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9085B8-86A9-4E5F-BBFC-BBD99D9D0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B3B987-0B15-4835-9466-D378DC5DC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C07BE3-A330-4B3F-B8C8-221544BB3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682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C8D33-B9CE-4060-86FF-D1E63DF07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2BDDC4-9E2C-470E-8614-FEF2C0C06F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CA981-C392-4CD8-874B-E445CA860D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4B2A15-259B-4351-97D8-AED26DAA9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4A461E-7716-4F2C-A590-7E9C5F5BC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60FD94-D0BF-4462-839C-302621E15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0007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4A57A-19A1-4077-8939-730B5FFA5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92A289-EDA8-44A2-BDF5-D7CF7A6889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92B2CC-1EE1-4F01-B2D8-3F59075915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5D7109-7E5E-4123-A877-9B5072C05A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79AE05-E585-4FEB-9FE4-5780487C8C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F49309-17B0-433A-86BE-A146548FA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FD9909-C228-4A80-8EE4-422032604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7FB830-4967-4887-832C-6DE14DA72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0569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78A0D-C8D7-41CD-9131-0FBA2A421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EA9B54-893B-4E50-94CD-8053CD06B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5BE61D-B329-4B2D-8E6C-4CBF322A2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A6BEC3-86B4-447C-A9EA-F11ADA3D8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588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314AE8A-D537-443B-97FE-D0A73B4506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F0BA55-1FEE-4324-9EA5-0596C0B5D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6D1075-0534-4C35-AA88-2767F4536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2644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58152F-F243-4D26-9E4A-DA17E8B265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B3255A-4C51-4196-A55C-F8E6119A96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006397-CE0B-4D42-9B8A-296B2A0EA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56B42B-99D5-45EE-8825-3C877B033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1BCDF0-27C7-4BEF-BF33-BBB1F02D4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076C0-854F-47BF-8811-28B3A6675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128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E49C9-BFAD-446C-809A-6BA92E4238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36115C-F9B9-4CF2-BD07-B2ED49320C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C80B9A-0C94-4FDB-BD83-29C4D85B25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D287A7-4E67-4825-8549-2CE233B7B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9D5B43-1D10-44D7-9329-2D734A5E5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DBA00B-0818-4388-9EC9-000329D2F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1059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CD8008-BD23-4FF3-B2C8-AEB1BFA1B9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C2C572-2629-4EB6-8B9C-6F580C9A4F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29891-84FF-4E29-8D3C-97CDFD2F13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E97E2-6761-46FF-B48E-E80B97A8F655}" type="datetimeFigureOut">
              <a:rPr lang="en-GB" smtClean="0"/>
              <a:t>14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F1E135-001E-4D84-A68E-E24216B85A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25D331-C372-4209-83CA-16098BF2E6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69173B-FA73-46A4-8B32-B3953617FC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4843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2472F351-6E36-575D-7245-D6CE2C5FBD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7037773"/>
              </p:ext>
            </p:extLst>
          </p:nvPr>
        </p:nvGraphicFramePr>
        <p:xfrm>
          <a:off x="119047" y="637289"/>
          <a:ext cx="11755452" cy="273253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827353">
                  <a:extLst>
                    <a:ext uri="{9D8B030D-6E8A-4147-A177-3AD203B41FA5}">
                      <a16:colId xmlns:a16="http://schemas.microsoft.com/office/drawing/2014/main" val="3505064390"/>
                    </a:ext>
                  </a:extLst>
                </a:gridCol>
                <a:gridCol w="5254968">
                  <a:extLst>
                    <a:ext uri="{9D8B030D-6E8A-4147-A177-3AD203B41FA5}">
                      <a16:colId xmlns:a16="http://schemas.microsoft.com/office/drawing/2014/main" val="3192034345"/>
                    </a:ext>
                  </a:extLst>
                </a:gridCol>
                <a:gridCol w="3673131">
                  <a:extLst>
                    <a:ext uri="{9D8B030D-6E8A-4147-A177-3AD203B41FA5}">
                      <a16:colId xmlns:a16="http://schemas.microsoft.com/office/drawing/2014/main" val="1868440926"/>
                    </a:ext>
                  </a:extLst>
                </a:gridCol>
              </a:tblGrid>
              <a:tr h="105307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endParaRPr lang="en-GB" sz="16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600" dirty="0" err="1"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pHR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600" dirty="0" err="1"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pHV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34831360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600" dirty="0"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Oncogene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600" i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DOT1L, EGFL7, EPHA7, GNB1, HDAC4, MECOM, MLLT10, NCOA3, NRG1, LRP6</a:t>
                      </a:r>
                      <a:endParaRPr lang="en-GB" sz="1600" i="1" dirty="0">
                        <a:effectLst/>
                        <a:latin typeface="Arial" panose="020B0604020202020204" pitchFamily="34" charset="0"/>
                        <a:ea typeface="SimSun" panose="02010600030101010101" pitchFamily="2" charset="-122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600" i="1" dirty="0"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ARID3B, CDC42, EGFL7, LRP6, ARHGAP35, CDK6, DOT1L, EPHA7, ERBB4, ETV1, HDAC4, NCOA3, NT5C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3258976"/>
                  </a:ext>
                </a:extLst>
              </a:tr>
              <a:tr h="175086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600" dirty="0"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Tumour suppressor gene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600" i="1" dirty="0"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CUL3, CUX1, EPHA7, HDAC4, NF1, POLE, SESN3, SPOP, ARID1A, ATXN2, CBL, CREBBP, EPHA3, KMT2C, SMG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600" i="1" dirty="0">
                          <a:effectLst/>
                          <a:latin typeface="Arial" panose="020B0604020202020204" pitchFamily="34" charset="0"/>
                          <a:ea typeface="SimSun" panose="02010600030101010101" pitchFamily="2" charset="-122"/>
                        </a:rPr>
                        <a:t>ARID4B, ATXN2, BLM, CBL, INPP4B, NCOR1, POLE, SMARCA4, ARHGAP35, ARID1A, ARID2, CUL3, EPHA7, HDAC4, NF1, NSD1, RAD51B, ROBO1, SMG1, SPOP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49219766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0BA7169-E582-4F49-DDD5-AB01A442F093}"/>
              </a:ext>
            </a:extLst>
          </p:cNvPr>
          <p:cNvSpPr txBox="1"/>
          <p:nvPr/>
        </p:nvSpPr>
        <p:spPr>
          <a:xfrm>
            <a:off x="119047" y="3509580"/>
            <a:ext cx="11755452" cy="707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4000"/>
              </a:lnSpc>
            </a:pPr>
            <a:r>
              <a:rPr lang="en-GB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mmary of oncogenes and tumour suppressor gene IS found with an increase in sequence count changes (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≥2-fold)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ver 30 days of outgrowth in iPSC. In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R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LV infected samples, 10 oncogenes and 15 tumour suppressor genes were identified. In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V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amples, 13 oncogenes and 20 tumour suppressor genes are identified to have differentially increase in sequence count changes over 30 day sampling period (</a:t>
            </a:r>
            <a:r>
              <a:rPr lang="en-GB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enjamini</a:t>
            </a:r>
            <a:r>
              <a:rPr lang="en-GB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Hoberg corrected p value p&lt;0.05</a:t>
            </a:r>
            <a:r>
              <a:rPr lang="en-GB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8A5621A-B316-FAB1-F7C6-71B7CCCB9842}"/>
              </a:ext>
            </a:extLst>
          </p:cNvPr>
          <p:cNvSpPr txBox="1"/>
          <p:nvPr/>
        </p:nvSpPr>
        <p:spPr>
          <a:xfrm>
            <a:off x="-1" y="220531"/>
            <a:ext cx="1057598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1. </a:t>
            </a:r>
            <a:r>
              <a:rPr lang="en-GB" sz="1200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ifferential sequence count chances in oncogene and tumour suppressor gene IS 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cross iPSC samples over 30 days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00915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83</TotalTime>
  <Words>219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qlain Suleman (Staff)</dc:creator>
  <cp:lastModifiedBy>Suleman, Saqlain</cp:lastModifiedBy>
  <cp:revision>31</cp:revision>
  <dcterms:created xsi:type="dcterms:W3CDTF">2024-01-05T10:52:35Z</dcterms:created>
  <dcterms:modified xsi:type="dcterms:W3CDTF">2025-04-14T17:21:59Z</dcterms:modified>
</cp:coreProperties>
</file>